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569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45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195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727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663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65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938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438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464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298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0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7C638-41AC-43DE-870B-BB46E476EB22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8A140-9B04-4DD7-B7B3-601D7862B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950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389" y="541885"/>
            <a:ext cx="9368444" cy="526975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20982" y="5249322"/>
            <a:ext cx="701594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Overlapping pathways targeted by the selected down- and upregulated in CRC miRNAs, which target upstream components of the adiponectin pathway, according to 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kiPathway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Pathways affected by the four downregulated miRNAs, which should exhibit higher activity in CRC;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– Pathways affected by the three upregulated miRNAs, which should exhibit lower activity in CRC. 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lappin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pathways are expected to exhibit higher complexity in their dysregulation in CRC.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9438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Светла Димитрова Славова</dc:creator>
  <cp:lastModifiedBy>Светла Димитрова Славова</cp:lastModifiedBy>
  <cp:revision>2</cp:revision>
  <dcterms:created xsi:type="dcterms:W3CDTF">2025-01-30T09:54:34Z</dcterms:created>
  <dcterms:modified xsi:type="dcterms:W3CDTF">2025-01-30T09:57:54Z</dcterms:modified>
</cp:coreProperties>
</file>